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8" r:id="rId4"/>
    <p:sldId id="266" r:id="rId5"/>
    <p:sldId id="262" r:id="rId6"/>
    <p:sldId id="257" r:id="rId7"/>
    <p:sldId id="260" r:id="rId8"/>
    <p:sldId id="263" r:id="rId9"/>
    <p:sldId id="264" r:id="rId10"/>
    <p:sldId id="265" r:id="rId11"/>
    <p:sldId id="272" r:id="rId12"/>
    <p:sldId id="273" r:id="rId13"/>
    <p:sldId id="274" r:id="rId14"/>
    <p:sldId id="268" r:id="rId15"/>
    <p:sldId id="270" r:id="rId16"/>
    <p:sldId id="271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14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298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10.vml.rels><?xml version="1.0" encoding="UTF-8" standalone="yes"?>
<Relationships xmlns="http://schemas.openxmlformats.org/package/2006/relationships"><Relationship Id="rId1" Type="http://schemas.openxmlformats.org/officeDocument/2006/relationships/image" Target="../media/image40.emf"/></Relationships>
</file>

<file path=ppt/drawings/_rels/vmlDrawing1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3.emf"/></Relationships>
</file>

<file path=ppt/drawings/_rels/vmlDrawing12.vml.rels><?xml version="1.0" encoding="UTF-8" standalone="yes"?>
<Relationships xmlns="http://schemas.openxmlformats.org/package/2006/relationships"><Relationship Id="rId1" Type="http://schemas.openxmlformats.org/officeDocument/2006/relationships/image" Target="../media/image46.emf"/></Relationships>
</file>

<file path=ppt/drawings/_rels/vmlDrawing1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image" Target="../media/image11.emf"/><Relationship Id="rId1" Type="http://schemas.openxmlformats.org/officeDocument/2006/relationships/image" Target="../media/image1.emf"/><Relationship Id="rId4" Type="http://schemas.openxmlformats.org/officeDocument/2006/relationships/image" Target="../media/image34.emf"/></Relationships>
</file>

<file path=ppt/drawings/_rels/vmlDrawing14.vml.rels><?xml version="1.0" encoding="UTF-8" standalone="yes"?>
<Relationships xmlns="http://schemas.openxmlformats.org/package/2006/relationships"><Relationship Id="rId3" Type="http://schemas.openxmlformats.org/officeDocument/2006/relationships/image" Target="../media/image58.emf"/><Relationship Id="rId2" Type="http://schemas.openxmlformats.org/officeDocument/2006/relationships/image" Target="../media/image57.emf"/><Relationship Id="rId1" Type="http://schemas.openxmlformats.org/officeDocument/2006/relationships/image" Target="../media/image56.emf"/><Relationship Id="rId5" Type="http://schemas.openxmlformats.org/officeDocument/2006/relationships/image" Target="../media/image60.emf"/><Relationship Id="rId4" Type="http://schemas.openxmlformats.org/officeDocument/2006/relationships/image" Target="../media/image59.emf"/></Relationships>
</file>

<file path=ppt/drawings/_rels/vmlDrawing15.vml.rels><?xml version="1.0" encoding="UTF-8" standalone="yes"?>
<Relationships xmlns="http://schemas.openxmlformats.org/package/2006/relationships"><Relationship Id="rId2" Type="http://schemas.openxmlformats.org/officeDocument/2006/relationships/image" Target="../media/image43.emf"/><Relationship Id="rId1" Type="http://schemas.openxmlformats.org/officeDocument/2006/relationships/image" Target="../media/image6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6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20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25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29.emf"/></Relationships>
</file>

<file path=ppt/drawings/_rels/vmlDrawing8.vml.rels><?xml version="1.0" encoding="UTF-8" standalone="yes"?>
<Relationships xmlns="http://schemas.openxmlformats.org/package/2006/relationships"><Relationship Id="rId1" Type="http://schemas.openxmlformats.org/officeDocument/2006/relationships/image" Target="../media/image34.emf"/></Relationships>
</file>

<file path=ppt/drawings/_rels/vmlDrawing9.vml.rels><?xml version="1.0" encoding="UTF-8" standalone="yes"?>
<Relationships xmlns="http://schemas.openxmlformats.org/package/2006/relationships"><Relationship Id="rId1" Type="http://schemas.openxmlformats.org/officeDocument/2006/relationships/image" Target="../media/image3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869D-67E9-43B8-BC62-AA895B02651E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C4AC5-AB99-4E47-B2A6-0583F0962B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760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869D-67E9-43B8-BC62-AA895B02651E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C4AC5-AB99-4E47-B2A6-0583F0962B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6774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869D-67E9-43B8-BC62-AA895B02651E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C4AC5-AB99-4E47-B2A6-0583F0962B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1977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869D-67E9-43B8-BC62-AA895B02651E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C4AC5-AB99-4E47-B2A6-0583F0962B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59444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869D-67E9-43B8-BC62-AA895B02651E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C4AC5-AB99-4E47-B2A6-0583F0962B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108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869D-67E9-43B8-BC62-AA895B02651E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C4AC5-AB99-4E47-B2A6-0583F0962B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8334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869D-67E9-43B8-BC62-AA895B02651E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C4AC5-AB99-4E47-B2A6-0583F0962B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6657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869D-67E9-43B8-BC62-AA895B02651E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C4AC5-AB99-4E47-B2A6-0583F0962B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3754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869D-67E9-43B8-BC62-AA895B02651E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C4AC5-AB99-4E47-B2A6-0583F0962B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981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869D-67E9-43B8-BC62-AA895B02651E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C4AC5-AB99-4E47-B2A6-0583F0962B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79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869D-67E9-43B8-BC62-AA895B02651E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C4AC5-AB99-4E47-B2A6-0583F0962B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721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B9869D-67E9-43B8-BC62-AA895B02651E}" type="datetimeFigureOut">
              <a:rPr lang="en-US" smtClean="0"/>
              <a:t>9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FC4AC5-AB99-4E47-B2A6-0583F0962B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551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emf"/><Relationship Id="rId3" Type="http://schemas.openxmlformats.org/officeDocument/2006/relationships/image" Target="../media/image2.tiff"/><Relationship Id="rId7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emf"/><Relationship Id="rId3" Type="http://schemas.openxmlformats.org/officeDocument/2006/relationships/image" Target="../media/image30.tiff"/><Relationship Id="rId7" Type="http://schemas.openxmlformats.org/officeDocument/2006/relationships/oleObject" Target="../embeddings/oleObject10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0.vml"/><Relationship Id="rId6" Type="http://schemas.openxmlformats.org/officeDocument/2006/relationships/image" Target="../media/image42.tiff"/><Relationship Id="rId5" Type="http://schemas.openxmlformats.org/officeDocument/2006/relationships/image" Target="../media/image3.tiff"/><Relationship Id="rId4" Type="http://schemas.openxmlformats.org/officeDocument/2006/relationships/image" Target="../media/image41.tif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tiff"/><Relationship Id="rId3" Type="http://schemas.openxmlformats.org/officeDocument/2006/relationships/image" Target="../media/image30.tiff"/><Relationship Id="rId7" Type="http://schemas.openxmlformats.org/officeDocument/2006/relationships/image" Target="../media/image45.tif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1.vml"/><Relationship Id="rId6" Type="http://schemas.openxmlformats.org/officeDocument/2006/relationships/image" Target="../media/image44.tiff"/><Relationship Id="rId5" Type="http://schemas.openxmlformats.org/officeDocument/2006/relationships/image" Target="../media/image43.emf"/><Relationship Id="rId4" Type="http://schemas.openxmlformats.org/officeDocument/2006/relationships/oleObject" Target="../embeddings/oleObject11.bin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emf"/><Relationship Id="rId3" Type="http://schemas.openxmlformats.org/officeDocument/2006/relationships/image" Target="../media/image47.tiff"/><Relationship Id="rId7" Type="http://schemas.openxmlformats.org/officeDocument/2006/relationships/oleObject" Target="../embeddings/oleObject1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2.vml"/><Relationship Id="rId6" Type="http://schemas.openxmlformats.org/officeDocument/2006/relationships/image" Target="../media/image49.tiff"/><Relationship Id="rId5" Type="http://schemas.openxmlformats.org/officeDocument/2006/relationships/image" Target="../media/image48.tiff"/><Relationship Id="rId4" Type="http://schemas.openxmlformats.org/officeDocument/2006/relationships/image" Target="../media/image4.tif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tiff"/><Relationship Id="rId7" Type="http://schemas.openxmlformats.org/officeDocument/2006/relationships/image" Target="../media/image55.tiff"/><Relationship Id="rId2" Type="http://schemas.openxmlformats.org/officeDocument/2006/relationships/image" Target="../media/image5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4.tiff"/><Relationship Id="rId5" Type="http://schemas.openxmlformats.org/officeDocument/2006/relationships/image" Target="../media/image53.tiff"/><Relationship Id="rId4" Type="http://schemas.openxmlformats.org/officeDocument/2006/relationships/image" Target="../media/image52.tiff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3.bin"/><Relationship Id="rId13" Type="http://schemas.openxmlformats.org/officeDocument/2006/relationships/image" Target="../media/image25.emf"/><Relationship Id="rId3" Type="http://schemas.openxmlformats.org/officeDocument/2006/relationships/image" Target="../media/image2.tiff"/><Relationship Id="rId7" Type="http://schemas.openxmlformats.org/officeDocument/2006/relationships/image" Target="../media/image36.tiff"/><Relationship Id="rId12" Type="http://schemas.openxmlformats.org/officeDocument/2006/relationships/oleObject" Target="../embeddings/oleObject15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3.vml"/><Relationship Id="rId6" Type="http://schemas.openxmlformats.org/officeDocument/2006/relationships/image" Target="../media/image28.tiff"/><Relationship Id="rId11" Type="http://schemas.openxmlformats.org/officeDocument/2006/relationships/image" Target="../media/image11.emf"/><Relationship Id="rId5" Type="http://schemas.openxmlformats.org/officeDocument/2006/relationships/image" Target="../media/image27.tiff"/><Relationship Id="rId15" Type="http://schemas.openxmlformats.org/officeDocument/2006/relationships/image" Target="../media/image34.emf"/><Relationship Id="rId10" Type="http://schemas.openxmlformats.org/officeDocument/2006/relationships/oleObject" Target="../embeddings/oleObject14.bin"/><Relationship Id="rId4" Type="http://schemas.openxmlformats.org/officeDocument/2006/relationships/image" Target="../media/image14.tiff"/><Relationship Id="rId9" Type="http://schemas.openxmlformats.org/officeDocument/2006/relationships/image" Target="../media/image1.emf"/><Relationship Id="rId14" Type="http://schemas.openxmlformats.org/officeDocument/2006/relationships/oleObject" Target="../embeddings/oleObject16.bin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emf"/><Relationship Id="rId13" Type="http://schemas.openxmlformats.org/officeDocument/2006/relationships/oleObject" Target="../embeddings/oleObject20.bin"/><Relationship Id="rId18" Type="http://schemas.openxmlformats.org/officeDocument/2006/relationships/image" Target="../media/image30.tiff"/><Relationship Id="rId3" Type="http://schemas.openxmlformats.org/officeDocument/2006/relationships/image" Target="../media/image9.tiff"/><Relationship Id="rId7" Type="http://schemas.openxmlformats.org/officeDocument/2006/relationships/oleObject" Target="../embeddings/oleObject18.bin"/><Relationship Id="rId12" Type="http://schemas.openxmlformats.org/officeDocument/2006/relationships/image" Target="../media/image31.tiff"/><Relationship Id="rId17" Type="http://schemas.openxmlformats.org/officeDocument/2006/relationships/image" Target="../media/image60.emf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21.bin"/><Relationship Id="rId1" Type="http://schemas.openxmlformats.org/officeDocument/2006/relationships/vmlDrawing" Target="../drawings/vmlDrawing14.vml"/><Relationship Id="rId6" Type="http://schemas.openxmlformats.org/officeDocument/2006/relationships/image" Target="../media/image17.tiff"/><Relationship Id="rId11" Type="http://schemas.openxmlformats.org/officeDocument/2006/relationships/image" Target="../media/image58.emf"/><Relationship Id="rId5" Type="http://schemas.openxmlformats.org/officeDocument/2006/relationships/image" Target="../media/image56.emf"/><Relationship Id="rId15" Type="http://schemas.openxmlformats.org/officeDocument/2006/relationships/image" Target="../media/image38.tiff"/><Relationship Id="rId10" Type="http://schemas.openxmlformats.org/officeDocument/2006/relationships/oleObject" Target="../embeddings/oleObject19.bin"/><Relationship Id="rId4" Type="http://schemas.openxmlformats.org/officeDocument/2006/relationships/oleObject" Target="../embeddings/oleObject17.bin"/><Relationship Id="rId9" Type="http://schemas.openxmlformats.org/officeDocument/2006/relationships/image" Target="../media/image21.tiff"/><Relationship Id="rId14" Type="http://schemas.openxmlformats.org/officeDocument/2006/relationships/image" Target="../media/image59.emf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3.bin"/><Relationship Id="rId3" Type="http://schemas.openxmlformats.org/officeDocument/2006/relationships/oleObject" Target="../embeddings/oleObject22.bin"/><Relationship Id="rId7" Type="http://schemas.openxmlformats.org/officeDocument/2006/relationships/image" Target="../media/image62.tif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5.vml"/><Relationship Id="rId6" Type="http://schemas.openxmlformats.org/officeDocument/2006/relationships/image" Target="../media/image42.tiff"/><Relationship Id="rId5" Type="http://schemas.openxmlformats.org/officeDocument/2006/relationships/image" Target="../media/image3.tiff"/><Relationship Id="rId4" Type="http://schemas.openxmlformats.org/officeDocument/2006/relationships/image" Target="../media/image61.emf"/><Relationship Id="rId9" Type="http://schemas.openxmlformats.org/officeDocument/2006/relationships/image" Target="../media/image4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tiff"/><Relationship Id="rId3" Type="http://schemas.openxmlformats.org/officeDocument/2006/relationships/oleObject" Target="../embeddings/oleObject2.bin"/><Relationship Id="rId7" Type="http://schemas.openxmlformats.org/officeDocument/2006/relationships/image" Target="../media/image9.tif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8.tiff"/><Relationship Id="rId5" Type="http://schemas.openxmlformats.org/officeDocument/2006/relationships/image" Target="../media/image7.tiff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tiff"/><Relationship Id="rId3" Type="http://schemas.openxmlformats.org/officeDocument/2006/relationships/oleObject" Target="../embeddings/oleObject3.bin"/><Relationship Id="rId7" Type="http://schemas.openxmlformats.org/officeDocument/2006/relationships/image" Target="../media/image14.tif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openxmlformats.org/officeDocument/2006/relationships/image" Target="../media/image11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3" Type="http://schemas.openxmlformats.org/officeDocument/2006/relationships/image" Target="../media/image7.tiff"/><Relationship Id="rId7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19.tiff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tiff"/><Relationship Id="rId3" Type="http://schemas.openxmlformats.org/officeDocument/2006/relationships/oleObject" Target="../embeddings/oleObject5.bin"/><Relationship Id="rId7" Type="http://schemas.openxmlformats.org/officeDocument/2006/relationships/image" Target="../media/image23.tif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22.tiff"/><Relationship Id="rId5" Type="http://schemas.openxmlformats.org/officeDocument/2006/relationships/image" Target="../media/image21.tiff"/><Relationship Id="rId4" Type="http://schemas.openxmlformats.org/officeDocument/2006/relationships/image" Target="../media/image20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tiff"/><Relationship Id="rId3" Type="http://schemas.openxmlformats.org/officeDocument/2006/relationships/image" Target="../media/image15.tiff"/><Relationship Id="rId7" Type="http://schemas.openxmlformats.org/officeDocument/2006/relationships/image" Target="../media/image27.tif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25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26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emf"/><Relationship Id="rId3" Type="http://schemas.openxmlformats.org/officeDocument/2006/relationships/image" Target="../media/image30.tiff"/><Relationship Id="rId7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33.tiff"/><Relationship Id="rId5" Type="http://schemas.openxmlformats.org/officeDocument/2006/relationships/image" Target="../media/image32.tiff"/><Relationship Id="rId4" Type="http://schemas.openxmlformats.org/officeDocument/2006/relationships/image" Target="../media/image31.tif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tiff"/><Relationship Id="rId3" Type="http://schemas.openxmlformats.org/officeDocument/2006/relationships/image" Target="../media/image22.tiff"/><Relationship Id="rId7" Type="http://schemas.openxmlformats.org/officeDocument/2006/relationships/image" Target="../media/image35.tif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6" Type="http://schemas.openxmlformats.org/officeDocument/2006/relationships/image" Target="../media/image34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15.tif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tiff"/><Relationship Id="rId3" Type="http://schemas.openxmlformats.org/officeDocument/2006/relationships/oleObject" Target="../embeddings/oleObject9.bin"/><Relationship Id="rId7" Type="http://schemas.openxmlformats.org/officeDocument/2006/relationships/image" Target="../media/image3.tif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6" Type="http://schemas.openxmlformats.org/officeDocument/2006/relationships/image" Target="../media/image30.tiff"/><Relationship Id="rId5" Type="http://schemas.openxmlformats.org/officeDocument/2006/relationships/image" Target="../media/image38.tiff"/><Relationship Id="rId4" Type="http://schemas.openxmlformats.org/officeDocument/2006/relationships/image" Target="../media/image3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9309" y="1588329"/>
            <a:ext cx="2647229" cy="89001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931" r="1982" b="39870"/>
          <a:stretch/>
        </p:blipFill>
        <p:spPr>
          <a:xfrm>
            <a:off x="2129309" y="2586790"/>
            <a:ext cx="2709754" cy="451184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776538" y="1848671"/>
            <a:ext cx="898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IAPH1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822667" y="2572069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5386138" y="172271"/>
            <a:ext cx="898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IAPH1</a:t>
            </a:r>
            <a:endParaRPr lang="en-US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1779" y="4368945"/>
            <a:ext cx="3413760" cy="786384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5875" y="3406761"/>
            <a:ext cx="3054096" cy="890016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5271838" y="3775729"/>
            <a:ext cx="898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IAPH1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5317967" y="4499127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7849407"/>
              </p:ext>
            </p:extLst>
          </p:nvPr>
        </p:nvGraphicFramePr>
        <p:xfrm>
          <a:off x="6827838" y="1757363"/>
          <a:ext cx="3840162" cy="3095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9" name="Prism 9" r:id="rId7" imgW="3839992" imgH="3096390" progId="Prism9.Document">
                  <p:embed/>
                </p:oleObj>
              </mc:Choice>
              <mc:Fallback>
                <p:oleObj name="Prism 9" r:id="rId7" imgW="3839992" imgH="309639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827838" y="1757363"/>
                        <a:ext cx="3840162" cy="3095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856373" y="1572697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1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856373" y="3482437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491098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5108" y="4003875"/>
            <a:ext cx="3233928" cy="139750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8453" y="3564963"/>
            <a:ext cx="2926080" cy="43891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8453" y="1606550"/>
            <a:ext cx="2764536" cy="172212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642" y="828131"/>
            <a:ext cx="2462784" cy="591312"/>
          </a:xfrm>
          <a:prstGeom prst="rect">
            <a:avLst/>
          </a:prstGeom>
        </p:spPr>
      </p:pic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7741162"/>
              </p:ext>
            </p:extLst>
          </p:nvPr>
        </p:nvGraphicFramePr>
        <p:xfrm>
          <a:off x="6318250" y="1606550"/>
          <a:ext cx="3836988" cy="3067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83" name="Prism 9" r:id="rId7" imgW="3837113" imgH="3067593" progId="Prism9.Document">
                  <p:embed/>
                </p:oleObj>
              </mc:Choice>
              <mc:Fallback>
                <p:oleObj name="Prism 9" r:id="rId7" imgW="3837113" imgH="3067593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318250" y="1606550"/>
                        <a:ext cx="3836988" cy="3067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4690089" y="3537249"/>
            <a:ext cx="7537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FN2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4479036" y="2312062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4671739" y="4676947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4355851" y="939121"/>
            <a:ext cx="7537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FN2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5354725" y="235904"/>
            <a:ext cx="7537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FN2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363264" y="1606550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1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363264" y="3516290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9139254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5108" y="4003875"/>
            <a:ext cx="3233928" cy="1397508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4690089" y="3537249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RP1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4870172" y="2170141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4671739" y="4676947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5109583" y="1233680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RP1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5354725" y="235904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RP1</a:t>
            </a:r>
            <a:endParaRPr lang="en-US" dirty="0"/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7596003"/>
              </p:ext>
            </p:extLst>
          </p:nvPr>
        </p:nvGraphicFramePr>
        <p:xfrm>
          <a:off x="6778625" y="1706880"/>
          <a:ext cx="3840163" cy="3122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75" name="Prism 9" r:id="rId4" imgW="3839992" imgH="3122307" progId="Prism9.Document">
                  <p:embed/>
                </p:oleObj>
              </mc:Choice>
              <mc:Fallback>
                <p:oleObj name="Prism 9" r:id="rId4" imgW="3839992" imgH="312230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778625" y="1706880"/>
                        <a:ext cx="3840163" cy="3122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543" b="56839"/>
          <a:stretch/>
        </p:blipFill>
        <p:spPr>
          <a:xfrm>
            <a:off x="1466088" y="3496490"/>
            <a:ext cx="3012948" cy="45085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3487" y="1281186"/>
            <a:ext cx="2596896" cy="39624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586" b="32866"/>
          <a:stretch/>
        </p:blipFill>
        <p:spPr>
          <a:xfrm>
            <a:off x="1714500" y="2002515"/>
            <a:ext cx="2764536" cy="646613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409568" y="1812175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1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409568" y="3721915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678232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0606" y="1500595"/>
            <a:ext cx="3413825" cy="52328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0670" y="2167899"/>
            <a:ext cx="3631565" cy="836557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6214182" y="4042539"/>
            <a:ext cx="747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INK1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6326833" y="2441709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6134150" y="4885952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6094431" y="1671343"/>
            <a:ext cx="747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INK1</a:t>
            </a:r>
            <a:endParaRPr lang="en-US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1012" y="4885952"/>
            <a:ext cx="3230880" cy="408432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89572" y="3625487"/>
            <a:ext cx="3413760" cy="786384"/>
          </a:xfrm>
          <a:prstGeom prst="rect">
            <a:avLst/>
          </a:prstGeom>
        </p:spPr>
      </p:pic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5010806"/>
              </p:ext>
            </p:extLst>
          </p:nvPr>
        </p:nvGraphicFramePr>
        <p:xfrm>
          <a:off x="7739698" y="1967555"/>
          <a:ext cx="3844925" cy="3122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395" name="Prism 9" r:id="rId7" imgW="3844672" imgH="3122307" progId="Prism9.Document">
                  <p:embed/>
                </p:oleObj>
              </mc:Choice>
              <mc:Fallback>
                <p:oleObj name="Prism 9" r:id="rId7" imgW="3844672" imgH="312230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739698" y="1967555"/>
                        <a:ext cx="3844925" cy="3122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5347111" y="263928"/>
            <a:ext cx="747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INK1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856373" y="1572697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1</a:t>
            </a:r>
            <a:endParaRPr 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856373" y="3482437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1708410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520018" y="316005"/>
            <a:ext cx="20292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Un cropped IP blots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0690" y="2195381"/>
            <a:ext cx="2000663" cy="59942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0690" y="1276140"/>
            <a:ext cx="2000663" cy="73152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871353" y="1354012"/>
            <a:ext cx="898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IAPH1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871353" y="2256637"/>
            <a:ext cx="7537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FN2</a:t>
            </a:r>
            <a:endParaRPr lang="en-US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1673" y="4255290"/>
            <a:ext cx="1758696" cy="1758696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6725" y="3336126"/>
            <a:ext cx="1688592" cy="816864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5026725" y="911842"/>
            <a:ext cx="1882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IAPH1 pull down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5026724" y="2915644"/>
            <a:ext cx="1738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FN2 pull down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6765405" y="3705006"/>
            <a:ext cx="898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IAPH1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6715317" y="4513670"/>
            <a:ext cx="7537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FN2</a:t>
            </a:r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77636" y="1538679"/>
            <a:ext cx="2123525" cy="564360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10211261" y="1538679"/>
            <a:ext cx="898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IAPH1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10211261" y="2195381"/>
            <a:ext cx="7537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FN1</a:t>
            </a:r>
            <a:endParaRPr lang="en-US" dirty="0"/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77635" y="2249512"/>
            <a:ext cx="2115419" cy="6661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900601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09" t="45269" r="11135" b="25667"/>
          <a:stretch/>
        </p:blipFill>
        <p:spPr>
          <a:xfrm>
            <a:off x="1400843" y="1531570"/>
            <a:ext cx="3572538" cy="45720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1593969" y="1162921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Scr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260255" y="1168660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DIAPH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263011" y="1169093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Scr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005196" y="1168660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DIAPH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1666107" y="1152641"/>
            <a:ext cx="138363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1979796" y="877913"/>
            <a:ext cx="8162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/>
          <p:cNvCxnSpPr/>
          <p:nvPr/>
        </p:nvCxnSpPr>
        <p:spPr>
          <a:xfrm>
            <a:off x="3358600" y="1152641"/>
            <a:ext cx="138363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825834" y="881838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/R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/>
          <p:cNvCxnSpPr/>
          <p:nvPr/>
        </p:nvCxnSpPr>
        <p:spPr>
          <a:xfrm flipV="1">
            <a:off x="1473514" y="1434181"/>
            <a:ext cx="73152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flipV="1">
            <a:off x="2357923" y="1434181"/>
            <a:ext cx="73152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 flipV="1">
            <a:off x="3220098" y="1434181"/>
            <a:ext cx="73152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V="1">
            <a:off x="4104507" y="1434181"/>
            <a:ext cx="73152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4962423" y="1531570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IAPH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65464" y="1669940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0k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Arrow Connector 23"/>
          <p:cNvCxnSpPr/>
          <p:nvPr/>
        </p:nvCxnSpPr>
        <p:spPr>
          <a:xfrm>
            <a:off x="1238417" y="1808440"/>
            <a:ext cx="15039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74" t="62019" r="8212" b="14532"/>
          <a:stretch/>
        </p:blipFill>
        <p:spPr>
          <a:xfrm>
            <a:off x="1400844" y="2144043"/>
            <a:ext cx="3572537" cy="45720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26" name="TextBox 25"/>
          <p:cNvSpPr txBox="1"/>
          <p:nvPr/>
        </p:nvSpPr>
        <p:spPr>
          <a:xfrm>
            <a:off x="665464" y="2230289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k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Arrow Connector 26"/>
          <p:cNvCxnSpPr/>
          <p:nvPr/>
        </p:nvCxnSpPr>
        <p:spPr>
          <a:xfrm>
            <a:off x="1238417" y="2368789"/>
            <a:ext cx="15039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962423" y="223744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RF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13" t="44070" r="5121" b="18623"/>
          <a:stretch/>
        </p:blipFill>
        <p:spPr>
          <a:xfrm>
            <a:off x="1400842" y="2756516"/>
            <a:ext cx="3584572" cy="45720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30" name="TextBox 29"/>
          <p:cNvSpPr txBox="1"/>
          <p:nvPr/>
        </p:nvSpPr>
        <p:spPr>
          <a:xfrm>
            <a:off x="750423" y="2876070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k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Straight Arrow Connector 30"/>
          <p:cNvCxnSpPr/>
          <p:nvPr/>
        </p:nvCxnSpPr>
        <p:spPr>
          <a:xfrm>
            <a:off x="1238417" y="3014570"/>
            <a:ext cx="15039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4962423" y="2846616"/>
            <a:ext cx="7615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KI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95" t="25851" r="4598" b="38731"/>
          <a:stretch/>
        </p:blipFill>
        <p:spPr>
          <a:xfrm>
            <a:off x="1408185" y="3946829"/>
            <a:ext cx="3575304" cy="456018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34" name="TextBox 33"/>
          <p:cNvSpPr txBox="1"/>
          <p:nvPr/>
        </p:nvSpPr>
        <p:spPr>
          <a:xfrm>
            <a:off x="749015" y="3939233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k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Arrow Connector 34"/>
          <p:cNvCxnSpPr/>
          <p:nvPr/>
        </p:nvCxnSpPr>
        <p:spPr>
          <a:xfrm>
            <a:off x="1237009" y="4077733"/>
            <a:ext cx="15039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4969765" y="3991828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91" t="50744" r="4892" b="36281"/>
          <a:stretch/>
        </p:blipFill>
        <p:spPr>
          <a:xfrm>
            <a:off x="1388811" y="3341649"/>
            <a:ext cx="3603946" cy="45720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38" name="TextBox 37"/>
          <p:cNvSpPr txBox="1"/>
          <p:nvPr/>
        </p:nvSpPr>
        <p:spPr>
          <a:xfrm>
            <a:off x="749015" y="3253317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Straight Arrow Connector 38"/>
          <p:cNvCxnSpPr/>
          <p:nvPr/>
        </p:nvCxnSpPr>
        <p:spPr>
          <a:xfrm>
            <a:off x="1237009" y="3391817"/>
            <a:ext cx="15039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4948188" y="3382653"/>
            <a:ext cx="806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DD34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2" name="Object 41"/>
          <p:cNvGraphicFramePr>
            <a:graphicFrameLocks noChangeAspect="1"/>
          </p:cNvGraphicFramePr>
          <p:nvPr>
            <p:extLst/>
          </p:nvPr>
        </p:nvGraphicFramePr>
        <p:xfrm>
          <a:off x="5937387" y="990020"/>
          <a:ext cx="2646751" cy="21335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46" name="Prism 9" r:id="rId8" imgW="3839992" imgH="3096390" progId="Prism9.Document">
                  <p:embed/>
                </p:oleObj>
              </mc:Choice>
              <mc:Fallback>
                <p:oleObj name="Prism 9" r:id="rId8" imgW="3839992" imgH="3096390" progId="Prism9.Document">
                  <p:embed/>
                  <p:pic>
                    <p:nvPicPr>
                      <p:cNvPr id="42" name="Object 41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937387" y="990020"/>
                        <a:ext cx="2646751" cy="21335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ct 42"/>
          <p:cNvGraphicFramePr>
            <a:graphicFrameLocks noChangeAspect="1"/>
          </p:cNvGraphicFramePr>
          <p:nvPr>
            <p:extLst/>
          </p:nvPr>
        </p:nvGraphicFramePr>
        <p:xfrm>
          <a:off x="8448207" y="990020"/>
          <a:ext cx="2639093" cy="21335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47" name="Prism 9" r:id="rId10" imgW="3829194" imgH="3096390" progId="Prism9.Document">
                  <p:embed/>
                </p:oleObj>
              </mc:Choice>
              <mc:Fallback>
                <p:oleObj name="Prism 9" r:id="rId10" imgW="3829194" imgH="3096390" progId="Prism9.Document">
                  <p:embed/>
                  <p:pic>
                    <p:nvPicPr>
                      <p:cNvPr id="43" name="Object 42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8448207" y="990020"/>
                        <a:ext cx="2639093" cy="21335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" name="Object 43"/>
          <p:cNvGraphicFramePr>
            <a:graphicFrameLocks noChangeAspect="1"/>
          </p:cNvGraphicFramePr>
          <p:nvPr>
            <p:extLst/>
          </p:nvPr>
        </p:nvGraphicFramePr>
        <p:xfrm>
          <a:off x="5941111" y="2925030"/>
          <a:ext cx="2557032" cy="21335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48" name="Prism 9" r:id="rId12" imgW="3710409" imgH="3096390" progId="Prism9.Document">
                  <p:embed/>
                </p:oleObj>
              </mc:Choice>
              <mc:Fallback>
                <p:oleObj name="Prism 9" r:id="rId12" imgW="3710409" imgH="3096390" progId="Prism9.Document">
                  <p:embed/>
                  <p:pic>
                    <p:nvPicPr>
                      <p:cNvPr id="44" name="Object 43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941111" y="2925030"/>
                        <a:ext cx="2557032" cy="21335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bject 44"/>
          <p:cNvGraphicFramePr>
            <a:graphicFrameLocks noChangeAspect="1"/>
          </p:cNvGraphicFramePr>
          <p:nvPr>
            <p:extLst/>
          </p:nvPr>
        </p:nvGraphicFramePr>
        <p:xfrm>
          <a:off x="8448206" y="2925030"/>
          <a:ext cx="2646752" cy="21521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49" name="Prism 9" r:id="rId14" imgW="3839992" imgH="3122307" progId="Prism9.Document">
                  <p:embed/>
                </p:oleObj>
              </mc:Choice>
              <mc:Fallback>
                <p:oleObj name="Prism 9" r:id="rId14" imgW="3839992" imgH="3122307" progId="Prism9.Document">
                  <p:embed/>
                  <p:pic>
                    <p:nvPicPr>
                      <p:cNvPr id="45" name="Object 44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8448206" y="2925030"/>
                        <a:ext cx="2646752" cy="21521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3399944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593969" y="1162921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Scr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260255" y="1168660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DIAPH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263011" y="1169093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Scr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005196" y="1168660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DIAPH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1666107" y="1152641"/>
            <a:ext cx="138363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1979796" y="877913"/>
            <a:ext cx="8162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/>
          <p:cNvCxnSpPr/>
          <p:nvPr/>
        </p:nvCxnSpPr>
        <p:spPr>
          <a:xfrm>
            <a:off x="3358600" y="1152641"/>
            <a:ext cx="138363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825834" y="881838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/R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/>
          <p:cNvCxnSpPr/>
          <p:nvPr/>
        </p:nvCxnSpPr>
        <p:spPr>
          <a:xfrm flipV="1">
            <a:off x="1473514" y="1434181"/>
            <a:ext cx="73152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flipV="1">
            <a:off x="2357923" y="1434181"/>
            <a:ext cx="73152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 flipV="1">
            <a:off x="3220098" y="1434181"/>
            <a:ext cx="73152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 flipV="1">
            <a:off x="4104507" y="1434181"/>
            <a:ext cx="73152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4957490" y="1588160"/>
            <a:ext cx="823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OMM40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750423" y="1735720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k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Arrow Connector 23"/>
          <p:cNvCxnSpPr/>
          <p:nvPr/>
        </p:nvCxnSpPr>
        <p:spPr>
          <a:xfrm>
            <a:off x="1238417" y="1874220"/>
            <a:ext cx="15039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750423" y="2230289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k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Straight Arrow Connector 26"/>
          <p:cNvCxnSpPr/>
          <p:nvPr/>
        </p:nvCxnSpPr>
        <p:spPr>
          <a:xfrm>
            <a:off x="1238417" y="2368789"/>
            <a:ext cx="15039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957490" y="221112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CL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750423" y="2573482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k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Straight Arrow Connector 30"/>
          <p:cNvCxnSpPr/>
          <p:nvPr/>
        </p:nvCxnSpPr>
        <p:spPr>
          <a:xfrm>
            <a:off x="1238417" y="2711982"/>
            <a:ext cx="15039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4957490" y="2761605"/>
            <a:ext cx="587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EFL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759691" y="4473083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k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Straight Arrow Connector 34"/>
          <p:cNvCxnSpPr/>
          <p:nvPr/>
        </p:nvCxnSpPr>
        <p:spPr>
          <a:xfrm>
            <a:off x="1246277" y="4611583"/>
            <a:ext cx="15039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4957490" y="4525678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665464" y="3137616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0k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Straight Arrow Connector 38"/>
          <p:cNvCxnSpPr/>
          <p:nvPr/>
        </p:nvCxnSpPr>
        <p:spPr>
          <a:xfrm>
            <a:off x="1237009" y="3286569"/>
            <a:ext cx="15039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4957490" y="3422833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25" t="47256" r="18103" b="33960"/>
          <a:stretch/>
        </p:blipFill>
        <p:spPr>
          <a:xfrm>
            <a:off x="1400841" y="1519106"/>
            <a:ext cx="3582647" cy="45720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graphicFrame>
        <p:nvGraphicFramePr>
          <p:cNvPr id="46" name="Object 45"/>
          <p:cNvGraphicFramePr>
            <a:graphicFrameLocks noChangeAspect="1"/>
          </p:cNvGraphicFramePr>
          <p:nvPr>
            <p:extLst/>
          </p:nvPr>
        </p:nvGraphicFramePr>
        <p:xfrm>
          <a:off x="6234843" y="470819"/>
          <a:ext cx="2803167" cy="228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79" name="Prism 9" r:id="rId4" imgW="3829194" imgH="3122307" progId="Prism9.Document">
                  <p:embed/>
                </p:oleObj>
              </mc:Choice>
              <mc:Fallback>
                <p:oleObj name="Prism 9" r:id="rId4" imgW="3829194" imgH="3122307" progId="Prism9.Document">
                  <p:embed/>
                  <p:pic>
                    <p:nvPicPr>
                      <p:cNvPr id="46" name="Object 45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234843" y="470819"/>
                        <a:ext cx="2803167" cy="228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09" t="23109" r="2883" b="49951"/>
          <a:stretch/>
        </p:blipFill>
        <p:spPr>
          <a:xfrm>
            <a:off x="1408184" y="2113877"/>
            <a:ext cx="3584573" cy="45720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graphicFrame>
        <p:nvGraphicFramePr>
          <p:cNvPr id="48" name="Object 47"/>
          <p:cNvGraphicFramePr>
            <a:graphicFrameLocks noChangeAspect="1"/>
          </p:cNvGraphicFramePr>
          <p:nvPr/>
        </p:nvGraphicFramePr>
        <p:xfrm>
          <a:off x="8933411" y="470819"/>
          <a:ext cx="2811303" cy="228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80" name="Prism 9" r:id="rId7" imgW="3839992" imgH="3122307" progId="Prism9.Document">
                  <p:embed/>
                </p:oleObj>
              </mc:Choice>
              <mc:Fallback>
                <p:oleObj name="Prism 9" r:id="rId7" imgW="3839992" imgH="3122307" progId="Prism9.Document">
                  <p:embed/>
                  <p:pic>
                    <p:nvPicPr>
                      <p:cNvPr id="48" name="Object 47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933411" y="470819"/>
                        <a:ext cx="2811303" cy="228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9" name="Picture 48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56" t="53125" r="837" b="18125"/>
          <a:stretch/>
        </p:blipFill>
        <p:spPr>
          <a:xfrm>
            <a:off x="1408184" y="2696746"/>
            <a:ext cx="3584574" cy="45720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graphicFrame>
        <p:nvGraphicFramePr>
          <p:cNvPr id="50" name="Object 49"/>
          <p:cNvGraphicFramePr>
            <a:graphicFrameLocks noChangeAspect="1"/>
          </p:cNvGraphicFramePr>
          <p:nvPr/>
        </p:nvGraphicFramePr>
        <p:xfrm>
          <a:off x="6234113" y="2536825"/>
          <a:ext cx="2808287" cy="2266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81" name="Prism 9" r:id="rId10" imgW="3837113" imgH="3096390" progId="Prism9.Document">
                  <p:embed/>
                </p:oleObj>
              </mc:Choice>
              <mc:Fallback>
                <p:oleObj name="Prism 9" r:id="rId10" imgW="3837113" imgH="3096390" progId="Prism9.Document">
                  <p:embed/>
                  <p:pic>
                    <p:nvPicPr>
                      <p:cNvPr id="50" name="Object 49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6234113" y="2536825"/>
                        <a:ext cx="2808287" cy="2266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1" name="Picture 50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90" t="55140" r="5954" b="9466"/>
          <a:stretch/>
        </p:blipFill>
        <p:spPr>
          <a:xfrm>
            <a:off x="1408184" y="3292553"/>
            <a:ext cx="3575304" cy="45338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graphicFrame>
        <p:nvGraphicFramePr>
          <p:cNvPr id="52" name="Object 51"/>
          <p:cNvGraphicFramePr>
            <a:graphicFrameLocks noChangeAspect="1"/>
          </p:cNvGraphicFramePr>
          <p:nvPr>
            <p:extLst/>
          </p:nvPr>
        </p:nvGraphicFramePr>
        <p:xfrm>
          <a:off x="8967788" y="2560638"/>
          <a:ext cx="2809875" cy="2244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82" name="Prism 9" r:id="rId13" imgW="3837113" imgH="3067593" progId="Prism9.Document">
                  <p:embed/>
                </p:oleObj>
              </mc:Choice>
              <mc:Fallback>
                <p:oleObj name="Prism 9" r:id="rId13" imgW="3837113" imgH="3067593" progId="Prism9.Document">
                  <p:embed/>
                  <p:pic>
                    <p:nvPicPr>
                      <p:cNvPr id="52" name="Object 51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8967788" y="2560638"/>
                        <a:ext cx="2809875" cy="2244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3" name="Picture 52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85" t="38560" r="4192" b="45082"/>
          <a:stretch/>
        </p:blipFill>
        <p:spPr>
          <a:xfrm>
            <a:off x="1408184" y="3882982"/>
            <a:ext cx="3584573" cy="45720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55" name="TextBox 54"/>
          <p:cNvSpPr txBox="1"/>
          <p:nvPr/>
        </p:nvSpPr>
        <p:spPr>
          <a:xfrm>
            <a:off x="750423" y="3846530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k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Straight Arrow Connector 55"/>
          <p:cNvCxnSpPr/>
          <p:nvPr/>
        </p:nvCxnSpPr>
        <p:spPr>
          <a:xfrm>
            <a:off x="1237009" y="3985030"/>
            <a:ext cx="15039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4957490" y="4014829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DEM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8" name="Object 57"/>
          <p:cNvGraphicFramePr>
            <a:graphicFrameLocks noChangeAspect="1"/>
          </p:cNvGraphicFramePr>
          <p:nvPr/>
        </p:nvGraphicFramePr>
        <p:xfrm>
          <a:off x="6230938" y="4545013"/>
          <a:ext cx="2811462" cy="2246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83" name="Prism 9" r:id="rId16" imgW="3839992" imgH="3067593" progId="Prism9.Document">
                  <p:embed/>
                </p:oleObj>
              </mc:Choice>
              <mc:Fallback>
                <p:oleObj name="Prism 9" r:id="rId16" imgW="3839992" imgH="3067593" progId="Prism9.Document">
                  <p:embed/>
                  <p:pic>
                    <p:nvPicPr>
                      <p:cNvPr id="58" name="Object 57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6230938" y="4545013"/>
                        <a:ext cx="2811462" cy="22463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53" t="47694" r="7832" b="22180"/>
          <a:stretch/>
        </p:blipFill>
        <p:spPr>
          <a:xfrm>
            <a:off x="1408184" y="4472029"/>
            <a:ext cx="3575304" cy="45720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04676968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3612384"/>
              </p:ext>
            </p:extLst>
          </p:nvPr>
        </p:nvGraphicFramePr>
        <p:xfrm>
          <a:off x="8423219" y="1434181"/>
          <a:ext cx="2808980" cy="228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62" name="Prism 9" r:id="rId3" imgW="3837113" imgH="3122307" progId="Prism9.Document">
                  <p:embed/>
                </p:oleObj>
              </mc:Choice>
              <mc:Fallback>
                <p:oleObj name="Prism 9" r:id="rId3" imgW="3837113" imgH="312230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423219" y="1434181"/>
                        <a:ext cx="2808980" cy="228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70" t="36278" r="12273" b="40577"/>
          <a:stretch/>
        </p:blipFill>
        <p:spPr>
          <a:xfrm>
            <a:off x="1398077" y="2739744"/>
            <a:ext cx="3575304" cy="45629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25" t="15955" r="6674" b="25559"/>
          <a:stretch/>
        </p:blipFill>
        <p:spPr>
          <a:xfrm>
            <a:off x="1398077" y="2145440"/>
            <a:ext cx="3575304" cy="45629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6" name="TextBox 5"/>
          <p:cNvSpPr txBox="1"/>
          <p:nvPr/>
        </p:nvSpPr>
        <p:spPr>
          <a:xfrm>
            <a:off x="1593969" y="1162921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Scr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260255" y="1168660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DIAPH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263011" y="1169093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Scr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005196" y="1168660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hDIAPH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/>
          <p:cNvCxnSpPr/>
          <p:nvPr/>
        </p:nvCxnSpPr>
        <p:spPr>
          <a:xfrm>
            <a:off x="1666107" y="1152641"/>
            <a:ext cx="138363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1979796" y="877913"/>
            <a:ext cx="8162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/>
          <p:cNvCxnSpPr/>
          <p:nvPr/>
        </p:nvCxnSpPr>
        <p:spPr>
          <a:xfrm>
            <a:off x="3358600" y="1152641"/>
            <a:ext cx="1383631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825834" y="881838"/>
            <a:ext cx="44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/R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 flipV="1">
            <a:off x="1473514" y="1434181"/>
            <a:ext cx="73152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 flipV="1">
            <a:off x="2357923" y="1434181"/>
            <a:ext cx="73152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V="1">
            <a:off x="3220098" y="1434181"/>
            <a:ext cx="73152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V="1">
            <a:off x="4104507" y="1434181"/>
            <a:ext cx="73152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4944790" y="2227304"/>
            <a:ext cx="6030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FN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749015" y="2227304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k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Arrow Connector 19"/>
          <p:cNvCxnSpPr/>
          <p:nvPr/>
        </p:nvCxnSpPr>
        <p:spPr>
          <a:xfrm>
            <a:off x="1238417" y="2310090"/>
            <a:ext cx="15039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749015" y="1601639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k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Straight Arrow Connector 22"/>
          <p:cNvCxnSpPr/>
          <p:nvPr/>
        </p:nvCxnSpPr>
        <p:spPr>
          <a:xfrm>
            <a:off x="1238417" y="1740139"/>
            <a:ext cx="15039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4944790" y="1659591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RP1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749015" y="2854853"/>
            <a:ext cx="5341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kd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Straight Arrow Connector 30"/>
          <p:cNvCxnSpPr/>
          <p:nvPr/>
        </p:nvCxnSpPr>
        <p:spPr>
          <a:xfrm>
            <a:off x="1238417" y="2993353"/>
            <a:ext cx="15039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4944790" y="2761031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44" t="12512" r="4729" b="56839"/>
          <a:stretch/>
        </p:blipFill>
        <p:spPr>
          <a:xfrm>
            <a:off x="1398077" y="1570964"/>
            <a:ext cx="3575304" cy="45720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graphicFrame>
        <p:nvGraphicFramePr>
          <p:cNvPr id="38" name="Object 3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27657806"/>
              </p:ext>
            </p:extLst>
          </p:nvPr>
        </p:nvGraphicFramePr>
        <p:xfrm>
          <a:off x="5792226" y="1434181"/>
          <a:ext cx="2811305" cy="2286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63" name="Prism 9" r:id="rId8" imgW="3839992" imgH="3122307" progId="Prism9.Document">
                  <p:embed/>
                </p:oleObj>
              </mc:Choice>
              <mc:Fallback>
                <p:oleObj name="Prism 9" r:id="rId8" imgW="3839992" imgH="3122307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792226" y="1434181"/>
                        <a:ext cx="2811305" cy="2286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966381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704975" y="202350"/>
            <a:ext cx="1123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OMM 40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4653021" y="1131731"/>
            <a:ext cx="107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OMM40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4725679" y="2103056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936813" y="4196801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67851" y="989067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1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4887134" y="3630496"/>
            <a:ext cx="107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OMM40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707435" y="3569187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2</a:t>
            </a:r>
            <a:endParaRPr lang="en-US" dirty="0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28905911"/>
              </p:ext>
            </p:extLst>
          </p:nvPr>
        </p:nvGraphicFramePr>
        <p:xfrm>
          <a:off x="6980405" y="2103056"/>
          <a:ext cx="3825875" cy="3127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9" name="Prism 9" r:id="rId3" imgW="3826314" imgH="3126987" progId="Prism9.Document">
                  <p:embed/>
                </p:oleObj>
              </mc:Choice>
              <mc:Fallback>
                <p:oleObj name="Prism 9" r:id="rId3" imgW="3826314" imgH="312698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980405" y="2103056"/>
                        <a:ext cx="3825875" cy="3127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203" b="24244"/>
          <a:stretch/>
        </p:blipFill>
        <p:spPr>
          <a:xfrm>
            <a:off x="1589279" y="4112841"/>
            <a:ext cx="3233928" cy="4572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433"/>
          <a:stretch/>
        </p:blipFill>
        <p:spPr>
          <a:xfrm>
            <a:off x="1589279" y="3165716"/>
            <a:ext cx="3233928" cy="92956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230" b="28952"/>
          <a:stretch/>
        </p:blipFill>
        <p:spPr>
          <a:xfrm>
            <a:off x="1627079" y="1021623"/>
            <a:ext cx="3017520" cy="589548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779" b="20624"/>
          <a:stretch/>
        </p:blipFill>
        <p:spPr>
          <a:xfrm>
            <a:off x="1812185" y="2039353"/>
            <a:ext cx="2621280" cy="4271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38114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704975" y="202350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RF2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4698341" y="1733724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RF2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4644599" y="2669361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5053263" y="3976231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RF2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5082444" y="4683565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856373" y="3482437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2</a:t>
            </a:r>
            <a:endParaRPr lang="en-US" dirty="0"/>
          </a:p>
        </p:txBody>
      </p:sp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2967716"/>
              </p:ext>
            </p:extLst>
          </p:nvPr>
        </p:nvGraphicFramePr>
        <p:xfrm>
          <a:off x="6994525" y="1374775"/>
          <a:ext cx="3829050" cy="3095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6" name="Prism 9" r:id="rId3" imgW="3829194" imgH="3096390" progId="Prism9.Document">
                  <p:embed/>
                </p:oleObj>
              </mc:Choice>
              <mc:Fallback>
                <p:oleObj name="Prism 9" r:id="rId3" imgW="3829194" imgH="309639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994525" y="1374775"/>
                        <a:ext cx="3829050" cy="3095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576"/>
          <a:stretch/>
        </p:blipFill>
        <p:spPr>
          <a:xfrm>
            <a:off x="1356599" y="2520615"/>
            <a:ext cx="3267456" cy="564007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0844"/>
          <a:stretch/>
        </p:blipFill>
        <p:spPr>
          <a:xfrm>
            <a:off x="1286424" y="1503145"/>
            <a:ext cx="3267456" cy="716681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598" b="4773"/>
          <a:stretch/>
        </p:blipFill>
        <p:spPr>
          <a:xfrm>
            <a:off x="1738217" y="3753853"/>
            <a:ext cx="3233928" cy="637673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96" t="20348" r="1558" b="34062"/>
          <a:stretch/>
        </p:blipFill>
        <p:spPr>
          <a:xfrm>
            <a:off x="1732547" y="4628368"/>
            <a:ext cx="3188369" cy="739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47236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704975" y="202350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CL2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3625" y="4668338"/>
            <a:ext cx="3233928" cy="107442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3625" y="3525338"/>
            <a:ext cx="3233928" cy="107442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4095" y="1875591"/>
            <a:ext cx="3230880" cy="67665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5313" y="1313017"/>
            <a:ext cx="2682240" cy="518160"/>
          </a:xfrm>
          <a:prstGeom prst="rect">
            <a:avLst/>
          </a:prstGeom>
        </p:spPr>
      </p:pic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576417"/>
              </p:ext>
            </p:extLst>
          </p:nvPr>
        </p:nvGraphicFramePr>
        <p:xfrm>
          <a:off x="7604125" y="1731870"/>
          <a:ext cx="3840163" cy="3122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7" name="Prism 9" r:id="rId7" imgW="3839992" imgH="3122307" progId="Prism9.Document">
                  <p:embed/>
                </p:oleObj>
              </mc:Choice>
              <mc:Fallback>
                <p:oleObj name="Prism 9" r:id="rId7" imgW="3839992" imgH="312230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604125" y="1731870"/>
                        <a:ext cx="3840163" cy="3122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5321969" y="1342515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CL2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5793649" y="2114191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321969" y="3725424"/>
            <a:ext cx="647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CL2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5237553" y="5108109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293538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704975" y="202350"/>
            <a:ext cx="6495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EFL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4633976" y="1098358"/>
            <a:ext cx="6495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EFL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4725679" y="2103056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5028831" y="4361747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67851" y="989067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1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5028831" y="3291735"/>
            <a:ext cx="6495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EFL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707435" y="3569187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2</a:t>
            </a:r>
            <a:endParaRPr lang="en-US" dirty="0"/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/>
        </p:nvGraphicFramePr>
        <p:xfrm>
          <a:off x="7373563" y="2188578"/>
          <a:ext cx="3835400" cy="3130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89" name="Prism 9" r:id="rId3" imgW="3835805" imgH="3130610" progId="Prism9.Document">
                  <p:embed/>
                </p:oleObj>
              </mc:Choice>
              <mc:Fallback>
                <p:oleObj name="Prism 9" r:id="rId3" imgW="3835805" imgH="3130610" progId="Prism9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373563" y="2188578"/>
                        <a:ext cx="3835400" cy="3130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9" name="Picture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7684" y="1039184"/>
            <a:ext cx="2182368" cy="48768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3760" y="1961726"/>
            <a:ext cx="2490216" cy="1030224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058" b="48969"/>
          <a:stretch/>
        </p:blipFill>
        <p:spPr>
          <a:xfrm>
            <a:off x="1669952" y="4421777"/>
            <a:ext cx="3288792" cy="470263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869" b="55466"/>
          <a:stretch/>
        </p:blipFill>
        <p:spPr>
          <a:xfrm>
            <a:off x="1744535" y="3272246"/>
            <a:ext cx="3288792" cy="5094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04911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704975" y="202350"/>
            <a:ext cx="8713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ARKIN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19236" r="2502" b="30727"/>
          <a:stretch/>
        </p:blipFill>
        <p:spPr>
          <a:xfrm>
            <a:off x="1875949" y="4581498"/>
            <a:ext cx="3303646" cy="81213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199" r="2503" b="21776"/>
          <a:stretch/>
        </p:blipFill>
        <p:spPr>
          <a:xfrm>
            <a:off x="1846768" y="3638229"/>
            <a:ext cx="3206495" cy="90838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743899" y="1735624"/>
            <a:ext cx="8713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ARKIN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4644599" y="2669361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5053263" y="3976231"/>
            <a:ext cx="8713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ARKIN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5082444" y="4683565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2357347"/>
              </p:ext>
            </p:extLst>
          </p:nvPr>
        </p:nvGraphicFramePr>
        <p:xfrm>
          <a:off x="7019925" y="1755775"/>
          <a:ext cx="3709988" cy="3095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2" name="Prism 9" r:id="rId5" imgW="3710409" imgH="3096390" progId="Prism9.Document">
                  <p:embed/>
                </p:oleObj>
              </mc:Choice>
              <mc:Fallback>
                <p:oleObj name="Prism 9" r:id="rId5" imgW="3710409" imgH="309639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019925" y="1755775"/>
                        <a:ext cx="3709988" cy="3095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4" name="Picture 1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28863" y="1208584"/>
            <a:ext cx="2584704" cy="999744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1533" y="2352207"/>
            <a:ext cx="2514600" cy="89154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856373" y="1572697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1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856373" y="3482437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576807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704975" y="202350"/>
            <a:ext cx="660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ERK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4633976" y="1098358"/>
            <a:ext cx="660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ERK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4725679" y="2103056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5028831" y="4361747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67851" y="989067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1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4970453" y="3506783"/>
            <a:ext cx="660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ERK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707435" y="3569187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2</a:t>
            </a:r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507" b="3063"/>
          <a:stretch/>
        </p:blipFill>
        <p:spPr>
          <a:xfrm>
            <a:off x="1731139" y="3996648"/>
            <a:ext cx="3233928" cy="9144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3863" y="3068467"/>
            <a:ext cx="3233928" cy="854964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3096" y="571682"/>
            <a:ext cx="3230880" cy="103632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9279" y="1740204"/>
            <a:ext cx="3136400" cy="1030224"/>
          </a:xfrm>
          <a:prstGeom prst="rect">
            <a:avLst/>
          </a:prstGeom>
        </p:spPr>
      </p:pic>
      <p:graphicFrame>
        <p:nvGraphicFramePr>
          <p:cNvPr id="21" name="Objec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9950969"/>
              </p:ext>
            </p:extLst>
          </p:nvPr>
        </p:nvGraphicFramePr>
        <p:xfrm>
          <a:off x="6964184" y="1722951"/>
          <a:ext cx="3832225" cy="3130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42" name="Prism 9" r:id="rId7" imgW="3832924" imgH="3130610" progId="Prism9.Document">
                  <p:embed/>
                </p:oleObj>
              </mc:Choice>
              <mc:Fallback>
                <p:oleObj name="Prism 9" r:id="rId7" imgW="3832924" imgH="313061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964184" y="1722951"/>
                        <a:ext cx="3832225" cy="3130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806145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704975" y="202350"/>
            <a:ext cx="9829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ADD34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4379294" y="1072832"/>
            <a:ext cx="9829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ADD34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4725679" y="2103056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5163523" y="5539719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567851" y="989067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1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5103170" y="3938519"/>
            <a:ext cx="9829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ADD34</a:t>
            </a: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707435" y="3569187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2</a:t>
            </a:r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3760" y="1961726"/>
            <a:ext cx="2490216" cy="1030224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9012" y="5097521"/>
            <a:ext cx="3288792" cy="1623060"/>
          </a:xfrm>
          <a:prstGeom prst="rect">
            <a:avLst/>
          </a:prstGeom>
        </p:spPr>
      </p:pic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6118710"/>
              </p:ext>
            </p:extLst>
          </p:nvPr>
        </p:nvGraphicFramePr>
        <p:xfrm>
          <a:off x="7108825" y="1419225"/>
          <a:ext cx="3840163" cy="3122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13" name="Prism 9" r:id="rId5" imgW="3839992" imgH="3122307" progId="Prism9.Document">
                  <p:embed/>
                </p:oleObj>
              </mc:Choice>
              <mc:Fallback>
                <p:oleObj name="Prism 9" r:id="rId5" imgW="3839992" imgH="312230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108825" y="1419225"/>
                        <a:ext cx="3840163" cy="3122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" name="Picture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1644" y="588366"/>
            <a:ext cx="2127504" cy="1060704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3986" y="2991950"/>
            <a:ext cx="3233928" cy="19705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015039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7272013"/>
              </p:ext>
            </p:extLst>
          </p:nvPr>
        </p:nvGraphicFramePr>
        <p:xfrm>
          <a:off x="7845788" y="1873431"/>
          <a:ext cx="3840163" cy="3122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35" name="Prism 9" r:id="rId3" imgW="3839992" imgH="3122307" progId="Prism9.Document">
                  <p:embed/>
                </p:oleObj>
              </mc:Choice>
              <mc:Fallback>
                <p:oleObj name="Prism 9" r:id="rId3" imgW="3839992" imgH="312230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845788" y="1873431"/>
                        <a:ext cx="3840163" cy="3122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704975" y="202350"/>
            <a:ext cx="865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DEM1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488" b="25086"/>
          <a:stretch/>
        </p:blipFill>
        <p:spPr>
          <a:xfrm>
            <a:off x="1605207" y="3373508"/>
            <a:ext cx="3233928" cy="83602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839032" y="3434737"/>
            <a:ext cx="865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DEM1</a:t>
            </a:r>
            <a:endParaRPr lang="en-US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5207" y="4297290"/>
            <a:ext cx="3233928" cy="1397508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725679" y="2103056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829286" y="4957798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ubulin</a:t>
            </a:r>
            <a:endParaRPr lang="en-US" dirty="0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586" b="32866"/>
          <a:stretch/>
        </p:blipFill>
        <p:spPr>
          <a:xfrm>
            <a:off x="1961143" y="1964415"/>
            <a:ext cx="2764536" cy="646613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944" b="20556"/>
          <a:stretch/>
        </p:blipFill>
        <p:spPr>
          <a:xfrm>
            <a:off x="1961143" y="1089659"/>
            <a:ext cx="2514600" cy="783772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4735425" y="1183060"/>
            <a:ext cx="865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DEM1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723363" y="1524997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1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723363" y="3434737"/>
            <a:ext cx="8818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atch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450394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48</TotalTime>
  <Words>165</Words>
  <Application>Microsoft Office PowerPoint</Application>
  <PresentationFormat>Widescreen</PresentationFormat>
  <Paragraphs>136</Paragraphs>
  <Slides>1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1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YU Langone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epuri, Gautham</dc:creator>
  <cp:lastModifiedBy>Yepuri, Gautham</cp:lastModifiedBy>
  <cp:revision>40</cp:revision>
  <dcterms:created xsi:type="dcterms:W3CDTF">2023-04-17T18:51:59Z</dcterms:created>
  <dcterms:modified xsi:type="dcterms:W3CDTF">2023-09-29T17:48:59Z</dcterms:modified>
</cp:coreProperties>
</file>